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797675" cy="992822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51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3729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08252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319295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9144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97259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2610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7128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48927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49451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055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4891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CB8350-8E5B-4CAC-9B30-3FD56F03CB62}" type="datetimeFigureOut">
              <a:rPr lang="ko-KR" altLang="en-US" smtClean="0"/>
              <a:t>2021-08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9ECE70-B72B-4143-A2C3-79E230FD8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80448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2471573" y="763957"/>
            <a:ext cx="764260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ry </a:t>
            </a:r>
            <a:r>
              <a:rPr kumimoji="0" lang="en-US" altLang="ko-KR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able S2</a:t>
            </a:r>
            <a:r>
              <a:rPr kumimoji="0" lang="en-US" altLang="ko-K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qPCR Primer Sequences for CORE, PRC, MYC module Markers (All </a:t>
            </a:r>
            <a:r>
              <a:rPr kumimoji="0" lang="en-US" altLang="ko-KR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anis lupus </a:t>
            </a:r>
            <a:r>
              <a:rPr kumimoji="0" lang="en-US" altLang="ko-KR" sz="1200" b="0" i="1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amiliaris</a:t>
            </a:r>
            <a:r>
              <a:rPr kumimoji="0" lang="en-US" altLang="ko-K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</a:t>
            </a:r>
            <a:endParaRPr kumimoji="0" lang="en-US" altLang="ko-KR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pic>
        <p:nvPicPr>
          <p:cNvPr id="2049" name="그림 1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5914" y="1298592"/>
            <a:ext cx="5734050" cy="4933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2849077" y="6392178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93296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96</TotalTime>
  <Words>21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LDS</dc:creator>
  <cp:lastModifiedBy>MDPI</cp:lastModifiedBy>
  <cp:revision>17</cp:revision>
  <cp:lastPrinted>2019-03-21T10:20:30Z</cp:lastPrinted>
  <dcterms:created xsi:type="dcterms:W3CDTF">2019-03-03T02:45:14Z</dcterms:created>
  <dcterms:modified xsi:type="dcterms:W3CDTF">2021-08-04T10:35:10Z</dcterms:modified>
</cp:coreProperties>
</file>